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26" d="100"/>
          <a:sy n="126" d="100"/>
        </p:scale>
        <p:origin x="-1242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FD862BB-71FA-4E71-B1C9-126C6A92AC09}" type="datetimeFigureOut">
              <a:rPr lang="en-US" smtClean="0"/>
              <a:t>5/4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D17D7F9-12F3-42FD-975E-7068238234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50642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THO439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01D5A40-DAB3-4397-A60B-E52DC0EC8A19}" type="slidenum">
              <a:rPr lang="en-US" smtClean="0">
                <a:solidFill>
                  <a:prstClr val="black"/>
                </a:solidFill>
              </a:rPr>
              <a:pPr/>
              <a:t>1</a:t>
            </a:fld>
            <a:endParaRPr 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0528978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301F1B-AA63-46AF-A84D-06CBE2FC954E}" type="datetimeFigureOut">
              <a:rPr lang="en-US" smtClean="0"/>
              <a:t>5/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B2CC57-3A1B-4CD0-AF6C-DD10B26E3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49785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301F1B-AA63-46AF-A84D-06CBE2FC954E}" type="datetimeFigureOut">
              <a:rPr lang="en-US" smtClean="0"/>
              <a:t>5/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B2CC57-3A1B-4CD0-AF6C-DD10B26E3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80682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301F1B-AA63-46AF-A84D-06CBE2FC954E}" type="datetimeFigureOut">
              <a:rPr lang="en-US" smtClean="0"/>
              <a:t>5/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B2CC57-3A1B-4CD0-AF6C-DD10B26E3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89524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301F1B-AA63-46AF-A84D-06CBE2FC954E}" type="datetimeFigureOut">
              <a:rPr lang="en-US" smtClean="0"/>
              <a:t>5/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B2CC57-3A1B-4CD0-AF6C-DD10B26E3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4720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301F1B-AA63-46AF-A84D-06CBE2FC954E}" type="datetimeFigureOut">
              <a:rPr lang="en-US" smtClean="0"/>
              <a:t>5/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B2CC57-3A1B-4CD0-AF6C-DD10B26E3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55071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301F1B-AA63-46AF-A84D-06CBE2FC954E}" type="datetimeFigureOut">
              <a:rPr lang="en-US" smtClean="0"/>
              <a:t>5/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B2CC57-3A1B-4CD0-AF6C-DD10B26E3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44965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301F1B-AA63-46AF-A84D-06CBE2FC954E}" type="datetimeFigureOut">
              <a:rPr lang="en-US" smtClean="0"/>
              <a:t>5/4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B2CC57-3A1B-4CD0-AF6C-DD10B26E3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61547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301F1B-AA63-46AF-A84D-06CBE2FC954E}" type="datetimeFigureOut">
              <a:rPr lang="en-US" smtClean="0"/>
              <a:t>5/4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B2CC57-3A1B-4CD0-AF6C-DD10B26E3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6003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301F1B-AA63-46AF-A84D-06CBE2FC954E}" type="datetimeFigureOut">
              <a:rPr lang="en-US" smtClean="0"/>
              <a:t>5/4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B2CC57-3A1B-4CD0-AF6C-DD10B26E3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00108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301F1B-AA63-46AF-A84D-06CBE2FC954E}" type="datetimeFigureOut">
              <a:rPr lang="en-US" smtClean="0"/>
              <a:t>5/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B2CC57-3A1B-4CD0-AF6C-DD10B26E3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6061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301F1B-AA63-46AF-A84D-06CBE2FC954E}" type="datetimeFigureOut">
              <a:rPr lang="en-US" smtClean="0"/>
              <a:t>5/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B2CC57-3A1B-4CD0-AF6C-DD10B26E3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99944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301F1B-AA63-46AF-A84D-06CBE2FC954E}" type="datetimeFigureOut">
              <a:rPr lang="en-US" smtClean="0"/>
              <a:t>5/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B2CC57-3A1B-4CD0-AF6C-DD10B26E3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96606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tiff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90600" y="4193262"/>
            <a:ext cx="7565231" cy="99012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15414" y="2269407"/>
            <a:ext cx="5870734" cy="10401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 rot="16200000">
            <a:off x="465341" y="4605394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sz="1000" b="1" baseline="-25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atio</a:t>
            </a:r>
          </a:p>
        </p:txBody>
      </p:sp>
      <p:grpSp>
        <p:nvGrpSpPr>
          <p:cNvPr id="5" name="Group 4"/>
          <p:cNvGrpSpPr/>
          <p:nvPr/>
        </p:nvGrpSpPr>
        <p:grpSpPr>
          <a:xfrm>
            <a:off x="8558331" y="4224040"/>
            <a:ext cx="269132" cy="959822"/>
            <a:chOff x="8749066" y="3276600"/>
            <a:chExt cx="269132" cy="959822"/>
          </a:xfrm>
        </p:grpSpPr>
        <p:sp>
          <p:nvSpPr>
            <p:cNvPr id="6" name="TextBox 5"/>
            <p:cNvSpPr txBox="1"/>
            <p:nvPr/>
          </p:nvSpPr>
          <p:spPr>
            <a:xfrm>
              <a:off x="8763000" y="3625709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8763000" y="3990201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8749066" y="3276600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</p:grpSp>
      <p:sp>
        <p:nvSpPr>
          <p:cNvPr id="9" name="TextBox 8"/>
          <p:cNvSpPr txBox="1"/>
          <p:nvPr/>
        </p:nvSpPr>
        <p:spPr>
          <a:xfrm>
            <a:off x="6664233" y="2040268"/>
            <a:ext cx="19463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romosome 1p31.3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5161872" y="3345078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JAK1</a:t>
            </a:r>
          </a:p>
        </p:txBody>
      </p:sp>
      <p:cxnSp>
        <p:nvCxnSpPr>
          <p:cNvPr id="12" name="Straight Arrow Connector 11"/>
          <p:cNvCxnSpPr/>
          <p:nvPr/>
        </p:nvCxnSpPr>
        <p:spPr>
          <a:xfrm flipV="1">
            <a:off x="5791200" y="3317034"/>
            <a:ext cx="0" cy="294429"/>
          </a:xfrm>
          <a:prstGeom prst="straightConnector1">
            <a:avLst/>
          </a:prstGeom>
          <a:ln w="2540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/>
          <p:cNvCxnSpPr/>
          <p:nvPr/>
        </p:nvCxnSpPr>
        <p:spPr>
          <a:xfrm>
            <a:off x="1219200" y="4193262"/>
            <a:ext cx="0" cy="242501"/>
          </a:xfrm>
          <a:prstGeom prst="straightConnector1">
            <a:avLst/>
          </a:prstGeom>
          <a:ln w="2540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7162800" y="3916263"/>
            <a:ext cx="12987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.5N genome</a:t>
            </a:r>
          </a:p>
        </p:txBody>
      </p:sp>
      <p:sp>
        <p:nvSpPr>
          <p:cNvPr id="17" name="TextBox 16"/>
          <p:cNvSpPr txBox="1"/>
          <p:nvPr/>
        </p:nvSpPr>
        <p:spPr>
          <a:xfrm rot="16200000">
            <a:off x="2357230" y="2689176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sz="1000" b="1" baseline="-25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atio</a:t>
            </a:r>
          </a:p>
        </p:txBody>
      </p:sp>
      <p:grpSp>
        <p:nvGrpSpPr>
          <p:cNvPr id="18" name="Group 17"/>
          <p:cNvGrpSpPr/>
          <p:nvPr/>
        </p:nvGrpSpPr>
        <p:grpSpPr>
          <a:xfrm>
            <a:off x="8686148" y="2286221"/>
            <a:ext cx="260008" cy="959822"/>
            <a:chOff x="8763000" y="3276600"/>
            <a:chExt cx="260008" cy="959822"/>
          </a:xfrm>
        </p:grpSpPr>
        <p:sp>
          <p:nvSpPr>
            <p:cNvPr id="19" name="TextBox 18"/>
            <p:cNvSpPr txBox="1"/>
            <p:nvPr/>
          </p:nvSpPr>
          <p:spPr>
            <a:xfrm>
              <a:off x="8763000" y="3625709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8763000" y="3990201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8763000" y="3276600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</p:grpSp>
      <p:sp>
        <p:nvSpPr>
          <p:cNvPr id="22" name="TextBox 21"/>
          <p:cNvSpPr txBox="1"/>
          <p:nvPr/>
        </p:nvSpPr>
        <p:spPr>
          <a:xfrm>
            <a:off x="6324600" y="6599802"/>
            <a:ext cx="28200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arrett et al., Supplemental Figure </a:t>
            </a:r>
            <a:r>
              <a:rPr lang="en-US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en-US" sz="1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3" name="Picture 2" descr="Y:\SORTS\Breast  TN  Mayo\Histograms Mcycle 2013\THO-439_001.fcs_PMT_9_Area-460div50.0.TIF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6653"/>
          <a:stretch/>
        </p:blipFill>
        <p:spPr bwMode="auto">
          <a:xfrm>
            <a:off x="907256" y="1752600"/>
            <a:ext cx="1699722" cy="20116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1826091" y="2937056"/>
            <a:ext cx="5629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.5N</a:t>
            </a:r>
            <a:endParaRPr 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1524000" y="2220198"/>
            <a:ext cx="5629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solidFill>
                  <a:srgbClr val="6699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.0N</a:t>
            </a:r>
            <a:endParaRPr lang="en-US" sz="1400" b="1" dirty="0">
              <a:solidFill>
                <a:srgbClr val="6699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209622" y="1414675"/>
            <a:ext cx="11592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TNBC-51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366860" y="179911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366860" y="412646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2730088" y="179911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295001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28</Words>
  <Application>Microsoft Office PowerPoint</Application>
  <PresentationFormat>On-screen Show (4:3)</PresentationFormat>
  <Paragraphs>20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ayo Clini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 T Barrett</dc:creator>
  <cp:lastModifiedBy>Michael T Barrett</cp:lastModifiedBy>
  <cp:revision>5</cp:revision>
  <dcterms:created xsi:type="dcterms:W3CDTF">2017-11-30T23:23:51Z</dcterms:created>
  <dcterms:modified xsi:type="dcterms:W3CDTF">2018-05-04T22:06:07Z</dcterms:modified>
</cp:coreProperties>
</file>